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721" autoAdjust="0"/>
    <p:restoredTop sz="94660"/>
  </p:normalViewPr>
  <p:slideViewPr>
    <p:cSldViewPr snapToGrid="0">
      <p:cViewPr>
        <p:scale>
          <a:sx n="100" d="100"/>
          <a:sy n="100" d="100"/>
        </p:scale>
        <p:origin x="4254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1543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1848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348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426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9816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650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0778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9500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58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9068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5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4989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>
            <a:extLst>
              <a:ext uri="{FF2B5EF4-FFF2-40B4-BE49-F238E27FC236}">
                <a16:creationId xmlns:a16="http://schemas.microsoft.com/office/drawing/2014/main" id="{39D2FD4E-2D8E-4D35-A6B5-3C4FC9A96D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8383" y="3429000"/>
            <a:ext cx="5301234" cy="2286000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:a16="http://schemas.microsoft.com/office/drawing/2014/main" id="{D6E1A081-679E-4335-9E64-ABC0ED4F2C9B}"/>
              </a:ext>
            </a:extLst>
          </p:cNvPr>
          <p:cNvSpPr/>
          <p:nvPr/>
        </p:nvSpPr>
        <p:spPr>
          <a:xfrm>
            <a:off x="600923" y="5715000"/>
            <a:ext cx="5890411" cy="7571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000" b="1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en-US" altLang="ko-KR" sz="1000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-gene interactions network of candidate genes associated with agronomic traits. Edges (gray line) indicate gene-gene interactions and node (gene) colors are arbitrary. Higher confidence scores are represented as thicker and darker lines</a:t>
            </a:r>
            <a:endParaRPr lang="ko-KR" altLang="ko-KR" sz="1000" kern="1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7110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3</TotalTime>
  <Words>40</Words>
  <Application>Microsoft Office PowerPoint</Application>
  <PresentationFormat>A4 용지(210x297mm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정민/원급(외부)/방사선육종연구실</dc:creator>
  <cp:lastModifiedBy>김정민/선임급(외부)/방사선육종연구실</cp:lastModifiedBy>
  <cp:revision>11</cp:revision>
  <dcterms:created xsi:type="dcterms:W3CDTF">2023-01-19T01:34:14Z</dcterms:created>
  <dcterms:modified xsi:type="dcterms:W3CDTF">2023-09-03T09:24:01Z</dcterms:modified>
</cp:coreProperties>
</file>